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029200" cy="36576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96FE24-AD93-48B6-8722-441642D819A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50920" y="145800"/>
            <a:ext cx="4527360" cy="60948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ctr">
            <a:noAutofit/>
          </a:bodyPr>
          <a:p>
            <a:pPr indent="0" algn="ctr">
              <a:buNone/>
              <a:tabLst>
                <a:tab algn="l" pos="0"/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50920" y="853560"/>
            <a:ext cx="4527360" cy="115092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50920" y="2114280"/>
            <a:ext cx="4527360" cy="115092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F899F6-D814-4269-8F46-9CCAA2C487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50920" y="145800"/>
            <a:ext cx="4527360" cy="60948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ctr">
            <a:noAutofit/>
          </a:bodyPr>
          <a:p>
            <a:pPr indent="0" algn="ctr">
              <a:buNone/>
              <a:tabLst>
                <a:tab algn="l" pos="0"/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50920" y="853560"/>
            <a:ext cx="2209320" cy="115092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571120" y="853560"/>
            <a:ext cx="2209320" cy="115092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50920" y="2114280"/>
            <a:ext cx="2209320" cy="115092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571120" y="2114280"/>
            <a:ext cx="2209320" cy="115092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3AD0C9-277A-415B-97C3-4D62F514EF3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50920" y="145800"/>
            <a:ext cx="4527360" cy="60948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ctr">
            <a:noAutofit/>
          </a:bodyPr>
          <a:p>
            <a:pPr indent="0" algn="ctr">
              <a:buNone/>
              <a:tabLst>
                <a:tab algn="l" pos="0"/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50920" y="853560"/>
            <a:ext cx="1457640" cy="115092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782000" y="853560"/>
            <a:ext cx="1457640" cy="115092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312720" y="853560"/>
            <a:ext cx="1457640" cy="115092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50920" y="2114280"/>
            <a:ext cx="1457640" cy="115092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782000" y="2114280"/>
            <a:ext cx="1457640" cy="115092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312720" y="2114280"/>
            <a:ext cx="1457640" cy="115092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550BC3-C86E-4235-9C6B-02642F763C2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50920" y="145800"/>
            <a:ext cx="4527360" cy="60948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ctr">
            <a:noAutofit/>
          </a:bodyPr>
          <a:p>
            <a:pPr indent="0" algn="ctr">
              <a:buNone/>
              <a:tabLst>
                <a:tab algn="l" pos="0"/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50920" y="853560"/>
            <a:ext cx="4527360" cy="2413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25"/>
              </a:spcBef>
              <a:buNone/>
              <a:tabLst>
                <a:tab algn="l" pos="0"/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18EB79-0861-4748-815A-37BEFB6E6A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50920" y="145800"/>
            <a:ext cx="4527360" cy="60948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ctr">
            <a:noAutofit/>
          </a:bodyPr>
          <a:p>
            <a:pPr indent="0" algn="ctr">
              <a:buNone/>
              <a:tabLst>
                <a:tab algn="l" pos="0"/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50920" y="853560"/>
            <a:ext cx="4527360" cy="241308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C88555-DF42-46EB-BDEA-ACC313AE12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50920" y="145800"/>
            <a:ext cx="4527360" cy="60948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ctr">
            <a:noAutofit/>
          </a:bodyPr>
          <a:p>
            <a:pPr indent="0" algn="ctr">
              <a:buNone/>
              <a:tabLst>
                <a:tab algn="l" pos="0"/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50920" y="853560"/>
            <a:ext cx="2209320" cy="241308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571120" y="853560"/>
            <a:ext cx="2209320" cy="241308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B89244-9FC9-4E35-BB06-FAD3F5BDB0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50920" y="145800"/>
            <a:ext cx="4527360" cy="60948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ctr">
            <a:noAutofit/>
          </a:bodyPr>
          <a:p>
            <a:pPr indent="0" algn="ctr">
              <a:buNone/>
              <a:tabLst>
                <a:tab algn="l" pos="0"/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BBD505-EF19-4FBF-90B7-E5C6446A21B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50920" y="145800"/>
            <a:ext cx="4527360" cy="2826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25"/>
              </a:spcBef>
              <a:tabLst>
                <a:tab algn="l" pos="0"/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01C886-A3CF-48E0-BE19-5A28FB6E68C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50920" y="145800"/>
            <a:ext cx="4527360" cy="60948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ctr">
            <a:noAutofit/>
          </a:bodyPr>
          <a:p>
            <a:pPr indent="0" algn="ctr">
              <a:buNone/>
              <a:tabLst>
                <a:tab algn="l" pos="0"/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50920" y="853560"/>
            <a:ext cx="2209320" cy="115092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571120" y="853560"/>
            <a:ext cx="2209320" cy="241308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50920" y="2114280"/>
            <a:ext cx="2209320" cy="115092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2773A7-437F-41EC-A4B9-A22B49148A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50920" y="145800"/>
            <a:ext cx="4527360" cy="60948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ctr">
            <a:noAutofit/>
          </a:bodyPr>
          <a:p>
            <a:pPr indent="0" algn="ctr">
              <a:buNone/>
              <a:tabLst>
                <a:tab algn="l" pos="0"/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50920" y="853560"/>
            <a:ext cx="2209320" cy="241308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571120" y="853560"/>
            <a:ext cx="2209320" cy="115092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571120" y="2114280"/>
            <a:ext cx="2209320" cy="115092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7C2F53-C0ED-4B4D-8DBA-A6CA0CAF32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50920" y="145800"/>
            <a:ext cx="4527360" cy="60948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ctr">
            <a:noAutofit/>
          </a:bodyPr>
          <a:p>
            <a:pPr indent="0" algn="ctr">
              <a:buNone/>
              <a:tabLst>
                <a:tab algn="l" pos="0"/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50920" y="853560"/>
            <a:ext cx="2209320" cy="115092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571120" y="853560"/>
            <a:ext cx="2209320" cy="115092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50920" y="2114280"/>
            <a:ext cx="4527360" cy="115092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t">
            <a:normAutofit/>
          </a:bodyPr>
          <a:p>
            <a:pPr indent="0">
              <a:spcBef>
                <a:spcPts val="425"/>
              </a:spcBef>
              <a:buNone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A28292-16FF-4F0E-B3AA-69354A5781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50920" y="145800"/>
            <a:ext cx="4527360" cy="60948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ctr">
            <a:noAutofit/>
          </a:bodyPr>
          <a:p>
            <a:pPr indent="0" algn="ctr">
              <a:buNone/>
              <a:tabLst>
                <a:tab algn="l" pos="0"/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50920" y="853560"/>
            <a:ext cx="4527360" cy="241308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t">
            <a:normAutofit/>
          </a:bodyPr>
          <a:p>
            <a:pPr marL="185760" indent="-185760">
              <a:spcBef>
                <a:spcPts val="425"/>
              </a:spcBef>
              <a:buClr>
                <a:srgbClr val="000000"/>
              </a:buClr>
              <a:buFont typeface="Arial"/>
              <a:buChar char="•"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  <a:p>
            <a:pPr lvl="1" marL="403200" indent="-154080">
              <a:spcBef>
                <a:spcPts val="425"/>
              </a:spcBef>
              <a:buClr>
                <a:srgbClr val="000000"/>
              </a:buClr>
              <a:buFont typeface="Arial"/>
              <a:buChar char="–"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  <a:p>
            <a:pPr lvl="2" marL="619200" indent="-123840">
              <a:spcBef>
                <a:spcPts val="425"/>
              </a:spcBef>
              <a:buClr>
                <a:srgbClr val="000000"/>
              </a:buClr>
              <a:buFont typeface="Arial"/>
              <a:buChar char="•"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  <a:p>
            <a:pPr lvl="3" marL="868320" indent="-123840">
              <a:spcBef>
                <a:spcPts val="425"/>
              </a:spcBef>
              <a:buClr>
                <a:srgbClr val="000000"/>
              </a:buClr>
              <a:buFont typeface="Arial"/>
              <a:buChar char="–"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  <a:p>
            <a:pPr lvl="4" marL="1116000" indent="-123840">
              <a:spcBef>
                <a:spcPts val="425"/>
              </a:spcBef>
              <a:buClr>
                <a:srgbClr val="000000"/>
              </a:buClr>
              <a:buFont typeface="Arial"/>
              <a:buChar char="»"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  <a:p>
            <a:pPr lvl="5" marL="1116000" indent="-123840">
              <a:spcBef>
                <a:spcPts val="425"/>
              </a:spcBef>
              <a:buClr>
                <a:srgbClr val="000000"/>
              </a:buClr>
              <a:buFont typeface="Arial"/>
              <a:buChar char="»"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  <a:p>
            <a:pPr lvl="6" marL="1116000" indent="-123840">
              <a:spcBef>
                <a:spcPts val="425"/>
              </a:spcBef>
              <a:buClr>
                <a:srgbClr val="000000"/>
              </a:buClr>
              <a:buFont typeface="Arial"/>
              <a:buChar char="»"/>
              <a:tabLst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1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50560" y="3389400"/>
            <a:ext cx="1174680" cy="19512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  <a:defRPr b="0" lang="en-US" sz="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r>
              <a:rPr b="0" lang="en-US" sz="7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717560" y="3389400"/>
            <a:ext cx="1594080" cy="19512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ctr">
            <a:noAutofit/>
          </a:bodyPr>
          <a:p>
            <a:pPr indent="0">
              <a:buNone/>
              <a:tabLst>
                <a:tab algn="l" pos="0"/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603240" y="3389400"/>
            <a:ext cx="1174680" cy="195120"/>
          </a:xfrm>
          <a:prstGeom prst="rect">
            <a:avLst/>
          </a:prstGeom>
          <a:noFill/>
          <a:ln w="0">
            <a:noFill/>
          </a:ln>
        </p:spPr>
        <p:txBody>
          <a:bodyPr lIns="49680" rIns="49680" tIns="24840" bIns="2484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  <a:defRPr b="0" lang="en-US" sz="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fld id="{445CC735-130D-402C-AE1F-38765FA8CAD2}" type="slidenum">
              <a:rPr b="0" lang="en-US" sz="7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6"/>
          <p:cNvGrpSpPr/>
          <p:nvPr/>
        </p:nvGrpSpPr>
        <p:grpSpPr>
          <a:xfrm>
            <a:off x="152280" y="76320"/>
            <a:ext cx="5029200" cy="3200400"/>
            <a:chOff x="152280" y="76320"/>
            <a:chExt cx="5029200" cy="3200400"/>
          </a:xfrm>
        </p:grpSpPr>
        <p:sp>
          <p:nvSpPr>
            <p:cNvPr id="42" name="TextBox 17"/>
            <p:cNvSpPr/>
            <p:nvPr/>
          </p:nvSpPr>
          <p:spPr>
            <a:xfrm rot="16200000">
              <a:off x="-910800" y="1173960"/>
              <a:ext cx="24336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95360"/>
                  <a:tab algn="l" pos="990720"/>
                  <a:tab algn="l" pos="1486080"/>
                  <a:tab algn="l" pos="1981080"/>
                  <a:tab algn="l" pos="2476440"/>
                  <a:tab algn="l" pos="2971800"/>
                  <a:tab algn="l" pos="3467160"/>
                  <a:tab algn="l" pos="3962520"/>
                  <a:tab algn="l" pos="4457880"/>
                  <a:tab algn="l" pos="4952880"/>
                  <a:tab algn="l" pos="5448240"/>
                  <a:tab algn="l" pos="5943600"/>
                  <a:tab algn="l" pos="6438960"/>
                  <a:tab algn="l" pos="6934320"/>
                  <a:tab algn="l" pos="7429680"/>
                  <a:tab algn="l" pos="7924680"/>
                  <a:tab algn="l" pos="8420040"/>
                  <a:tab algn="l" pos="8915400"/>
                  <a:tab algn="l" pos="9410760"/>
                  <a:tab algn="l" pos="990612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</a:rPr>
                <a:t>Changes of Fluo-3 intensity (%)</a:t>
              </a: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3" name="Chart 18" descr=""/>
            <p:cNvPicPr/>
            <p:nvPr/>
          </p:nvPicPr>
          <p:blipFill>
            <a:blip r:embed="rId1"/>
            <a:stretch/>
          </p:blipFill>
          <p:spPr>
            <a:xfrm>
              <a:off x="377280" y="76320"/>
              <a:ext cx="4804200" cy="32004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44" name="Rectangle 19"/>
          <p:cNvSpPr/>
          <p:nvPr/>
        </p:nvSpPr>
        <p:spPr>
          <a:xfrm>
            <a:off x="380880" y="2819520"/>
            <a:ext cx="457200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95360"/>
                <a:tab algn="l" pos="990720"/>
                <a:tab algn="l" pos="1486080"/>
                <a:tab algn="l" pos="1981080"/>
                <a:tab algn="l" pos="2476440"/>
                <a:tab algn="l" pos="2971800"/>
                <a:tab algn="l" pos="3467160"/>
                <a:tab algn="l" pos="3962520"/>
                <a:tab algn="l" pos="4457880"/>
                <a:tab algn="l" pos="4952880"/>
                <a:tab algn="l" pos="5448240"/>
                <a:tab algn="l" pos="5943600"/>
                <a:tab algn="l" pos="6438960"/>
                <a:tab algn="l" pos="6934320"/>
                <a:tab algn="l" pos="7429680"/>
                <a:tab algn="l" pos="7924680"/>
                <a:tab algn="l" pos="8420040"/>
                <a:tab algn="l" pos="8915400"/>
                <a:tab algn="l" pos="9410760"/>
                <a:tab algn="l" pos="990612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Figure1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 Photobleach was estimated from the same field of cells that had no response to menthol and capsaicin. The figure shows the changes of Fluo-3 intensity in these cells (n = 14).  The intensity was 98.8% ± 0.98 of control at the end of 5-min Ca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Calibri"/>
              </a:rPr>
              <a:t>2+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 imaging experiments.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28T13:35:38Z</dcterms:created>
  <dc:creator>Jianguo Gu</dc:creator>
  <dc:description/>
  <dc:language>en-US</dc:language>
  <cp:lastModifiedBy>sarriaio</cp:lastModifiedBy>
  <dcterms:modified xsi:type="dcterms:W3CDTF">2010-08-11T16:50:11Z</dcterms:modified>
  <cp:revision>6</cp:revision>
  <dc:subject/>
  <dc:title>Slide 1</dc:title>
</cp:coreProperties>
</file>